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63" r:id="rId4"/>
    <p:sldId id="265" r:id="rId5"/>
    <p:sldId id="264" r:id="rId6"/>
    <p:sldId id="260" r:id="rId7"/>
    <p:sldId id="259" r:id="rId8"/>
    <p:sldId id="2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ennedy Mwai" userId="bc103fda-9b69-43dc-9bc8-b8c90128b386" providerId="ADAL" clId="{3C519DCC-006D-4FEC-A412-32A54347088E}"/>
    <pc:docChg chg="custSel modSld">
      <pc:chgData name="Kennedy Mwai" userId="bc103fda-9b69-43dc-9bc8-b8c90128b386" providerId="ADAL" clId="{3C519DCC-006D-4FEC-A412-32A54347088E}" dt="2022-10-22T08:45:08.726" v="30" actId="1076"/>
      <pc:docMkLst>
        <pc:docMk/>
      </pc:docMkLst>
      <pc:sldChg chg="modSp mod">
        <pc:chgData name="Kennedy Mwai" userId="bc103fda-9b69-43dc-9bc8-b8c90128b386" providerId="ADAL" clId="{3C519DCC-006D-4FEC-A412-32A54347088E}" dt="2022-10-22T08:44:23.871" v="4" actId="20577"/>
        <pc:sldMkLst>
          <pc:docMk/>
          <pc:sldMk cId="2165701985" sldId="258"/>
        </pc:sldMkLst>
        <pc:spChg chg="mod">
          <ac:chgData name="Kennedy Mwai" userId="bc103fda-9b69-43dc-9bc8-b8c90128b386" providerId="ADAL" clId="{3C519DCC-006D-4FEC-A412-32A54347088E}" dt="2022-10-22T08:44:23.871" v="4" actId="20577"/>
          <ac:spMkLst>
            <pc:docMk/>
            <pc:sldMk cId="2165701985" sldId="258"/>
            <ac:spMk id="3" creationId="{626B7BFF-FB22-4224-8F10-1B9C95F70969}"/>
          </ac:spMkLst>
        </pc:spChg>
      </pc:sldChg>
      <pc:sldChg chg="modSp mod">
        <pc:chgData name="Kennedy Mwai" userId="bc103fda-9b69-43dc-9bc8-b8c90128b386" providerId="ADAL" clId="{3C519DCC-006D-4FEC-A412-32A54347088E}" dt="2022-10-22T08:44:43.908" v="25" actId="20577"/>
        <pc:sldMkLst>
          <pc:docMk/>
          <pc:sldMk cId="4235821064" sldId="259"/>
        </pc:sldMkLst>
        <pc:spChg chg="mod">
          <ac:chgData name="Kennedy Mwai" userId="bc103fda-9b69-43dc-9bc8-b8c90128b386" providerId="ADAL" clId="{3C519DCC-006D-4FEC-A412-32A54347088E}" dt="2022-10-22T08:44:43.908" v="25" actId="20577"/>
          <ac:spMkLst>
            <pc:docMk/>
            <pc:sldMk cId="4235821064" sldId="259"/>
            <ac:spMk id="6" creationId="{8F7FC090-AA8F-414F-AD82-FD3554FE6752}"/>
          </ac:spMkLst>
        </pc:spChg>
      </pc:sldChg>
      <pc:sldChg chg="modSp mod">
        <pc:chgData name="Kennedy Mwai" userId="bc103fda-9b69-43dc-9bc8-b8c90128b386" providerId="ADAL" clId="{3C519DCC-006D-4FEC-A412-32A54347088E}" dt="2022-10-22T08:44:37.193" v="18" actId="20577"/>
        <pc:sldMkLst>
          <pc:docMk/>
          <pc:sldMk cId="1269449640" sldId="260"/>
        </pc:sldMkLst>
        <pc:spChg chg="mod">
          <ac:chgData name="Kennedy Mwai" userId="bc103fda-9b69-43dc-9bc8-b8c90128b386" providerId="ADAL" clId="{3C519DCC-006D-4FEC-A412-32A54347088E}" dt="2022-10-22T08:44:37.193" v="18" actId="20577"/>
          <ac:spMkLst>
            <pc:docMk/>
            <pc:sldMk cId="1269449640" sldId="260"/>
            <ac:spMk id="3" creationId="{C54C064A-C49E-4972-A96B-34B0A57676CD}"/>
          </ac:spMkLst>
        </pc:spChg>
      </pc:sldChg>
      <pc:sldChg chg="modSp mod">
        <pc:chgData name="Kennedy Mwai" userId="bc103fda-9b69-43dc-9bc8-b8c90128b386" providerId="ADAL" clId="{3C519DCC-006D-4FEC-A412-32A54347088E}" dt="2022-10-22T08:45:08.726" v="30" actId="1076"/>
        <pc:sldMkLst>
          <pc:docMk/>
          <pc:sldMk cId="1886904427" sldId="262"/>
        </pc:sldMkLst>
        <pc:spChg chg="mod">
          <ac:chgData name="Kennedy Mwai" userId="bc103fda-9b69-43dc-9bc8-b8c90128b386" providerId="ADAL" clId="{3C519DCC-006D-4FEC-A412-32A54347088E}" dt="2022-10-22T08:44:47.443" v="28" actId="20577"/>
          <ac:spMkLst>
            <pc:docMk/>
            <pc:sldMk cId="1886904427" sldId="262"/>
            <ac:spMk id="2" creationId="{35B422F5-2AFF-413A-A347-A39BCB836019}"/>
          </ac:spMkLst>
        </pc:spChg>
        <pc:picChg chg="mod modCrop">
          <ac:chgData name="Kennedy Mwai" userId="bc103fda-9b69-43dc-9bc8-b8c90128b386" providerId="ADAL" clId="{3C519DCC-006D-4FEC-A412-32A54347088E}" dt="2022-10-22T08:45:08.726" v="30" actId="1076"/>
          <ac:picMkLst>
            <pc:docMk/>
            <pc:sldMk cId="1886904427" sldId="262"/>
            <ac:picMk id="3" creationId="{C70A5708-BCBD-4DCA-A529-9319840C7916}"/>
          </ac:picMkLst>
        </pc:picChg>
      </pc:sldChg>
      <pc:sldChg chg="modSp mod">
        <pc:chgData name="Kennedy Mwai" userId="bc103fda-9b69-43dc-9bc8-b8c90128b386" providerId="ADAL" clId="{3C519DCC-006D-4FEC-A412-32A54347088E}" dt="2022-10-22T08:44:27.759" v="9" actId="20577"/>
        <pc:sldMkLst>
          <pc:docMk/>
          <pc:sldMk cId="310348889" sldId="263"/>
        </pc:sldMkLst>
        <pc:spChg chg="mod">
          <ac:chgData name="Kennedy Mwai" userId="bc103fda-9b69-43dc-9bc8-b8c90128b386" providerId="ADAL" clId="{3C519DCC-006D-4FEC-A412-32A54347088E}" dt="2022-10-22T08:44:27.759" v="9" actId="20577"/>
          <ac:spMkLst>
            <pc:docMk/>
            <pc:sldMk cId="310348889" sldId="263"/>
            <ac:spMk id="2" creationId="{F699FA71-3C7F-4CCE-9CC9-DDB3C7F15C15}"/>
          </ac:spMkLst>
        </pc:spChg>
      </pc:sldChg>
      <pc:sldChg chg="modSp mod">
        <pc:chgData name="Kennedy Mwai" userId="bc103fda-9b69-43dc-9bc8-b8c90128b386" providerId="ADAL" clId="{3C519DCC-006D-4FEC-A412-32A54347088E}" dt="2022-10-22T08:44:33.600" v="14" actId="20577"/>
        <pc:sldMkLst>
          <pc:docMk/>
          <pc:sldMk cId="1865526045" sldId="264"/>
        </pc:sldMkLst>
        <pc:spChg chg="mod">
          <ac:chgData name="Kennedy Mwai" userId="bc103fda-9b69-43dc-9bc8-b8c90128b386" providerId="ADAL" clId="{3C519DCC-006D-4FEC-A412-32A54347088E}" dt="2022-10-22T08:44:33.600" v="14" actId="20577"/>
          <ac:spMkLst>
            <pc:docMk/>
            <pc:sldMk cId="1865526045" sldId="264"/>
            <ac:spMk id="2" creationId="{73F3CAFD-7B39-4656-83C9-D3028F36A82B}"/>
          </ac:spMkLst>
        </pc:spChg>
      </pc:sldChg>
    </pc:docChg>
  </pc:docChgLst>
  <pc:docChgLst>
    <pc:chgData name="Kennedy Mwai" userId="bc103fda-9b69-43dc-9bc8-b8c90128b386" providerId="ADAL" clId="{42854CDC-BDAE-4B7B-A8F9-5969C1935471}"/>
    <pc:docChg chg="undo custSel addSld modSld">
      <pc:chgData name="Kennedy Mwai" userId="bc103fda-9b69-43dc-9bc8-b8c90128b386" providerId="ADAL" clId="{42854CDC-BDAE-4B7B-A8F9-5969C1935471}" dt="2022-08-25T19:27:18.806" v="73" actId="20577"/>
      <pc:docMkLst>
        <pc:docMk/>
      </pc:docMkLst>
      <pc:sldChg chg="addSp delSp modSp new mod setBg">
        <pc:chgData name="Kennedy Mwai" userId="bc103fda-9b69-43dc-9bc8-b8c90128b386" providerId="ADAL" clId="{42854CDC-BDAE-4B7B-A8F9-5969C1935471}" dt="2022-08-25T19:27:18.806" v="73" actId="20577"/>
        <pc:sldMkLst>
          <pc:docMk/>
          <pc:sldMk cId="855425332" sldId="265"/>
        </pc:sldMkLst>
        <pc:spChg chg="mod">
          <ac:chgData name="Kennedy Mwai" userId="bc103fda-9b69-43dc-9bc8-b8c90128b386" providerId="ADAL" clId="{42854CDC-BDAE-4B7B-A8F9-5969C1935471}" dt="2022-08-25T19:27:18.806" v="73" actId="20577"/>
          <ac:spMkLst>
            <pc:docMk/>
            <pc:sldMk cId="855425332" sldId="265"/>
            <ac:spMk id="2" creationId="{3E44DB33-6C28-AE00-BD31-1F3D13E62594}"/>
          </ac:spMkLst>
        </pc:spChg>
        <pc:graphicFrameChg chg="add del mod">
          <ac:chgData name="Kennedy Mwai" userId="bc103fda-9b69-43dc-9bc8-b8c90128b386" providerId="ADAL" clId="{42854CDC-BDAE-4B7B-A8F9-5969C1935471}" dt="2022-08-25T19:23:26.923" v="6"/>
          <ac:graphicFrameMkLst>
            <pc:docMk/>
            <pc:sldMk cId="855425332" sldId="265"/>
            <ac:graphicFrameMk id="3" creationId="{8B4E4DC3-80AA-C01F-A621-2FE738E662FD}"/>
          </ac:graphicFrameMkLst>
        </pc:graphicFrameChg>
        <pc:graphicFrameChg chg="add del mod">
          <ac:chgData name="Kennedy Mwai" userId="bc103fda-9b69-43dc-9bc8-b8c90128b386" providerId="ADAL" clId="{42854CDC-BDAE-4B7B-A8F9-5969C1935471}" dt="2022-08-25T19:23:26.923" v="6"/>
          <ac:graphicFrameMkLst>
            <pc:docMk/>
            <pc:sldMk cId="855425332" sldId="265"/>
            <ac:graphicFrameMk id="4" creationId="{51353D7E-BA56-35F7-64C5-7AFF56524FD6}"/>
          </ac:graphicFrameMkLst>
        </pc:graphicFrameChg>
        <pc:graphicFrameChg chg="add del mod">
          <ac:chgData name="Kennedy Mwai" userId="bc103fda-9b69-43dc-9bc8-b8c90128b386" providerId="ADAL" clId="{42854CDC-BDAE-4B7B-A8F9-5969C1935471}" dt="2022-08-25T19:23:37.438" v="8"/>
          <ac:graphicFrameMkLst>
            <pc:docMk/>
            <pc:sldMk cId="855425332" sldId="265"/>
            <ac:graphicFrameMk id="5" creationId="{E4BFD83D-5A25-BDAE-DCA1-6BCACC707817}"/>
          </ac:graphicFrameMkLst>
        </pc:graphicFrameChg>
        <pc:graphicFrameChg chg="add del mod">
          <ac:chgData name="Kennedy Mwai" userId="bc103fda-9b69-43dc-9bc8-b8c90128b386" providerId="ADAL" clId="{42854CDC-BDAE-4B7B-A8F9-5969C1935471}" dt="2022-08-25T19:23:50.642" v="10"/>
          <ac:graphicFrameMkLst>
            <pc:docMk/>
            <pc:sldMk cId="855425332" sldId="265"/>
            <ac:graphicFrameMk id="6" creationId="{AF178E2B-4F32-7FBC-F05F-4A170C8131DA}"/>
          </ac:graphicFrameMkLst>
        </pc:graphicFrameChg>
        <pc:graphicFrameChg chg="add mod modGraphic">
          <ac:chgData name="Kennedy Mwai" userId="bc103fda-9b69-43dc-9bc8-b8c90128b386" providerId="ADAL" clId="{42854CDC-BDAE-4B7B-A8F9-5969C1935471}" dt="2022-08-25T19:24:35.889" v="26" actId="404"/>
          <ac:graphicFrameMkLst>
            <pc:docMk/>
            <pc:sldMk cId="855425332" sldId="265"/>
            <ac:graphicFrameMk id="7" creationId="{697D3B84-530B-E30C-002F-3C98FC7FE8F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388AC5-CB55-4CDC-A004-5274B6EF0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A0E0BF7-5A8F-4B3E-9529-CB31E7426E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6F3494-FF90-4BA6-89AB-D860B2816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F18844-2EBF-41D9-8E36-838D8FF28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0BF6DD-105D-4B07-8594-84F803C66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551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C5A2CE-C368-496A-8FD9-EBFCF75806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99A13D-B2D6-437C-BB97-C0F73A16E0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7671D1-2833-4399-AFA4-EAE61719D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70A18B-679B-4CA7-B633-9DEA500D2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244D8D-FE9E-4436-9ECC-8853B5C14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2966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147582-B08A-4C5E-8596-641FD78A17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BB199D-246A-4AA6-9939-DD2DFEADBA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FBA163-F638-40DC-BDE7-1F353A942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AC218C-64F7-4D73-8671-E076B3432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AFE377-7953-41CE-ACD6-18126378A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6492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45FB67-D8B7-439E-87A7-3540F6EFB3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65013E-2707-4FC3-8696-8AB4AB322C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82CABC-FB25-4678-BE7F-D7AB96FBB8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9159E8-3631-4963-B4B8-3D22BFAF9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66646-9C61-43F3-A8F0-94CD166B5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7107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8F4E89-82BD-453A-AB1E-DFB98C5636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7785D0-8E3C-42F8-8E11-A1CE88AE07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EFEF78-B140-4763-901B-8B398A920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A8AFE-F9C3-48B8-8D75-A7A8BD738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5DAD7A-8E7E-46D1-B35C-37E23D929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76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26D7B9-4E3F-4042-83EC-D14B64FFC5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706542-76A1-42F5-BA0D-9AD34E84E8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44D2EB-4295-4294-AAAF-5F0CA1586C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1ABF94-BBDF-4534-A293-9E666BDD8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D737F9-0838-4650-BD5E-35B986159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5F120D-6ACC-4B24-A4BB-A5F894A17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2562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D903B9-5ACC-4855-BB7C-4E7874AD9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401F96-AF9A-46F5-A392-5C90369955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77603B-0AEC-4AFA-966F-4EFCC56A6C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38ADAE-4D73-40FB-9CF1-3D11A16A0F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6A1E94-372E-406E-AB0A-7FA84EC526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719BEB-7470-4879-8D5F-2E75707B8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F059244-B23D-4B94-A9AD-B2B67C86E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28E736-2F97-4918-AA95-99EF234EF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3070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D63FAA-94F6-4B18-88E8-281DF1C2AC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1D9E649-C528-442B-9105-CD3160E72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DCBCE8-F05C-4FF7-A58A-DFD21DD32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566009-39C1-4432-BA54-CA9C15B5B1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0545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E4A8F52-CA38-4B52-99BE-0D32A51A7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66A9CF-4F13-46CA-9BB8-7207B9D89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C17486-9C85-4C1F-8B60-44C837F22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4078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F174F4-4F6F-40D1-BDA9-C0174485B5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CDFCF7-13CA-43BA-A86C-C1C4FA7DF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E3743A-C963-4616-A6FE-3714C7E522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91CBB0-20AC-4933-885C-F8085AB8B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BAD850-08FD-47EB-AEE6-92C1BA242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29D424-EEBC-431C-81BB-A3ABAA932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2324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6C3FF6-83E8-4A3E-A419-957826A38E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BAF3E3-CD59-45FD-A64F-A7F5EE3B8B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205B88-839D-42B2-8539-D5BA454E48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DB06C9-EC96-419B-A6B4-BA957087D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7EC142-82A3-49D5-86BA-593B39CCF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FDA210-75A1-4509-B75D-6B710F50C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176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928268-5A53-45E5-B973-FB7B8B35CF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A472B6-BF8C-4E96-8775-2DE57B7432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4D9993-8834-4E42-8A27-CD769BFAD8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37C89B-E9D1-43C9-B6CC-DE998963450D}" type="datetimeFigureOut">
              <a:rPr lang="en-GB" smtClean="0"/>
              <a:t>22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0CF27F-D90D-4B55-BBED-99DDB16637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CDB1C0-FB11-4569-815E-3675FB378F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3A17F-9D53-481D-810B-6BE3ADED05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264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FD842EE7-74AB-413C-9239-529E1F6D76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0913" y="175121"/>
            <a:ext cx="11521491" cy="677094"/>
          </a:xfrm>
        </p:spPr>
        <p:txBody>
          <a:bodyPr>
            <a:noAutofit/>
          </a:bodyPr>
          <a:lstStyle/>
          <a:p>
            <a:pPr algn="l" fontAlgn="b"/>
            <a:r>
              <a:rPr lang="en-GB" sz="3200" dirty="0"/>
              <a:t>Supplementary Table 1 :</a:t>
            </a:r>
            <a:r>
              <a:rPr lang="en-GB" sz="3200" u="none" strike="noStrike" dirty="0">
                <a:effectLst/>
              </a:rPr>
              <a:t>Parasites/µL cut off using Logistic regression</a:t>
            </a:r>
            <a:endParaRPr lang="en-GB" sz="3200" b="0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25CD55B-6945-42F3-84A4-76374D482F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3765622"/>
              </p:ext>
            </p:extLst>
          </p:nvPr>
        </p:nvGraphicFramePr>
        <p:xfrm>
          <a:off x="1373567" y="957674"/>
          <a:ext cx="9260566" cy="5581627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865426">
                  <a:extLst>
                    <a:ext uri="{9D8B030D-6E8A-4147-A177-3AD203B41FA5}">
                      <a16:colId xmlns:a16="http://schemas.microsoft.com/office/drawing/2014/main" val="2284825941"/>
                    </a:ext>
                  </a:extLst>
                </a:gridCol>
                <a:gridCol w="1676765">
                  <a:extLst>
                    <a:ext uri="{9D8B030D-6E8A-4147-A177-3AD203B41FA5}">
                      <a16:colId xmlns:a16="http://schemas.microsoft.com/office/drawing/2014/main" val="2957461780"/>
                    </a:ext>
                  </a:extLst>
                </a:gridCol>
                <a:gridCol w="1370260">
                  <a:extLst>
                    <a:ext uri="{9D8B030D-6E8A-4147-A177-3AD203B41FA5}">
                      <a16:colId xmlns:a16="http://schemas.microsoft.com/office/drawing/2014/main" val="1417492093"/>
                    </a:ext>
                  </a:extLst>
                </a:gridCol>
                <a:gridCol w="1748883">
                  <a:extLst>
                    <a:ext uri="{9D8B030D-6E8A-4147-A177-3AD203B41FA5}">
                      <a16:colId xmlns:a16="http://schemas.microsoft.com/office/drawing/2014/main" val="2975205882"/>
                    </a:ext>
                  </a:extLst>
                </a:gridCol>
                <a:gridCol w="883456">
                  <a:extLst>
                    <a:ext uri="{9D8B030D-6E8A-4147-A177-3AD203B41FA5}">
                      <a16:colId xmlns:a16="http://schemas.microsoft.com/office/drawing/2014/main" val="363783355"/>
                    </a:ext>
                  </a:extLst>
                </a:gridCol>
                <a:gridCol w="870043">
                  <a:extLst>
                    <a:ext uri="{9D8B030D-6E8A-4147-A177-3AD203B41FA5}">
                      <a16:colId xmlns:a16="http://schemas.microsoft.com/office/drawing/2014/main" val="2055643465"/>
                    </a:ext>
                  </a:extLst>
                </a:gridCol>
                <a:gridCol w="1845733">
                  <a:extLst>
                    <a:ext uri="{9D8B030D-6E8A-4147-A177-3AD203B41FA5}">
                      <a16:colId xmlns:a16="http://schemas.microsoft.com/office/drawing/2014/main" val="784042495"/>
                    </a:ext>
                  </a:extLst>
                </a:gridCol>
              </a:tblGrid>
              <a:tr h="396000"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u="none" strike="noStrike" dirty="0">
                          <a:effectLst/>
                        </a:rPr>
                        <a:t>Year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u="none" strike="noStrike" dirty="0">
                          <a:effectLst/>
                        </a:rPr>
                        <a:t>Parasites/µL cut off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u="none" strike="noStrike" dirty="0">
                          <a:effectLst/>
                        </a:rPr>
                        <a:t>Malaria Positive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Malaria Positive by 2500 p/µ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u="none" strike="noStrike" dirty="0">
                          <a:effectLst/>
                        </a:rPr>
                        <a:t>Sensitivity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u="none" strike="noStrike" dirty="0">
                          <a:effectLst/>
                        </a:rPr>
                        <a:t>Specificity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u="none" strike="noStrike" dirty="0">
                          <a:effectLst/>
                        </a:rPr>
                        <a:t>Lambda (UL - LL)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1609266231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200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2000 p/µL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7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7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9.6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0.2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1.11 (77.96,84.25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1980364914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0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1300 p/µL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4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4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1.0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0.9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60.57 (60.44,60.7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2567147976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0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00 p/µL 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56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4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1.8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1.2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4.99 (82.91,87.04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2881070748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08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500 p/µL 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2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129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7.2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6.08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7.29 (85.67,88.9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3745570683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0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800 p/µL 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0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102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7.8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8.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2.38 (80.83,83.93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4081418040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1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3000 p/µL 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3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137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9.0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8.9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9.96 (88.8,91.11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1103586563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1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200 p/µL 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2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1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87.93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7.8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1.07 (90.27,91.89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2683643560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2012*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1000 p/µL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8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95.39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94.4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65.01 (55.3,74.56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3524615198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1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500 p/µL 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7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7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7.0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86.7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0.56 (90.15,90.99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344136518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1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3500 p/µL 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1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5.2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85.41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8.17 (87.65,88.67)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766572577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1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3500 p/µL 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5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58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7.2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87.4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83.56 (82.38,84.69)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1744575429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01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500 p/µL 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0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0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2.9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1.9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85.37 (83.32,87.44)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3723856008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2017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500 p/µL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62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5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4.6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95.0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92.80 (91.73,93.84)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07" marR="6907" marT="6907" marB="0" anchor="ctr"/>
                </a:tc>
                <a:extLst>
                  <a:ext uri="{0D108BD9-81ED-4DB2-BD59-A6C34878D82A}">
                    <a16:rowId xmlns:a16="http://schemas.microsoft.com/office/drawing/2014/main" val="3419048668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92B960E-D1DE-432A-A871-C190FF57B5C5}"/>
              </a:ext>
            </a:extLst>
          </p:cNvPr>
          <p:cNvSpPr txBox="1"/>
          <p:nvPr/>
        </p:nvSpPr>
        <p:spPr>
          <a:xfrm>
            <a:off x="2097974" y="6522004"/>
            <a:ext cx="9120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i="1" dirty="0">
                <a:solidFill>
                  <a:srgbClr val="1F497D"/>
                </a:solidFill>
                <a:effectLst/>
                <a:latin typeface="Tahoma" panose="020B060403050404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*Excluded in the main analysis due to health workers' strike. </a:t>
            </a:r>
            <a:endParaRPr lang="en-GB" sz="1800" i="1" dirty="0">
              <a:solidFill>
                <a:srgbClr val="1F497D"/>
              </a:solidFill>
              <a:effectLst/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743207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58440DA-EC15-44FB-B20C-3206AB04AA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4994" y="902017"/>
            <a:ext cx="10884724" cy="5855549"/>
          </a:xfrm>
          <a:prstGeom prst="rect">
            <a:avLst/>
          </a:prstGeom>
        </p:spPr>
      </p:pic>
      <p:sp>
        <p:nvSpPr>
          <p:cNvPr id="3" name="Title 2">
            <a:extLst>
              <a:ext uri="{FF2B5EF4-FFF2-40B4-BE49-F238E27FC236}">
                <a16:creationId xmlns:a16="http://schemas.microsoft.com/office/drawing/2014/main" id="{626B7BFF-FB22-4224-8F10-1B9C95F709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85684" y="100434"/>
            <a:ext cx="10515600" cy="801583"/>
          </a:xfrm>
        </p:spPr>
        <p:txBody>
          <a:bodyPr>
            <a:normAutofit/>
          </a:bodyPr>
          <a:lstStyle/>
          <a:p>
            <a:r>
              <a:rPr lang="en-GB" sz="3200" dirty="0"/>
              <a:t>Supplementary </a:t>
            </a:r>
            <a:r>
              <a:rPr lang="en-US" sz="3200" dirty="0"/>
              <a:t>Fig 1: Distribution of predicted probabilities</a:t>
            </a:r>
            <a:endParaRPr lang="en-GB" sz="3200" dirty="0"/>
          </a:p>
        </p:txBody>
      </p:sp>
    </p:spTree>
    <p:extLst>
      <p:ext uri="{BB962C8B-B14F-4D97-AF65-F5344CB8AC3E}">
        <p14:creationId xmlns:p14="http://schemas.microsoft.com/office/powerpoint/2010/main" val="21657019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99FA71-3C7F-4CCE-9CC9-DDB3C7F15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4855" y="309707"/>
            <a:ext cx="11084626" cy="1036163"/>
          </a:xfrm>
        </p:spPr>
        <p:txBody>
          <a:bodyPr>
            <a:normAutofit/>
          </a:bodyPr>
          <a:lstStyle/>
          <a:p>
            <a:r>
              <a:rPr lang="en-GB" sz="3200" dirty="0"/>
              <a:t>Supplementary </a:t>
            </a:r>
            <a:r>
              <a:rPr lang="en-US" sz="3200" dirty="0"/>
              <a:t>Fig 2: Comparison of probabilities for Bayesian and Logistic, </a:t>
            </a:r>
            <a:r>
              <a:rPr lang="en-US" sz="3200" dirty="0" err="1"/>
              <a:t>Junju</a:t>
            </a:r>
            <a:r>
              <a:rPr lang="en-US" sz="3200" dirty="0"/>
              <a:t> 2008</a:t>
            </a:r>
            <a:endParaRPr lang="en-GB" sz="3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90FE18F-E504-413F-A144-46796E1304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5318" y="1497878"/>
            <a:ext cx="6369212" cy="49939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3488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44DB33-6C28-AE00-BD31-1F3D13E625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291089"/>
            <a:ext cx="10974356" cy="1285783"/>
          </a:xfrm>
        </p:spPr>
        <p:txBody>
          <a:bodyPr vert="horz" lIns="91440" tIns="45720" rIns="91440" bIns="45720" rtlCol="0" anchor="b">
            <a:normAutofit fontScale="90000"/>
          </a:bodyPr>
          <a:lstStyle/>
          <a:p>
            <a:r>
              <a:rPr lang="en-GB" sz="5400" dirty="0"/>
              <a:t>Supplementary Table 2: </a:t>
            </a:r>
            <a:r>
              <a:rPr lang="en-GB" sz="5400" dirty="0" err="1"/>
              <a:t>Anova</a:t>
            </a:r>
            <a:r>
              <a:rPr lang="en-GB" sz="5400" dirty="0"/>
              <a:t> test for </a:t>
            </a:r>
            <a:r>
              <a:rPr lang="en-GB" sz="5400"/>
              <a:t>Figure 2B</a:t>
            </a:r>
            <a:endParaRPr lang="en-US" sz="54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97D3B84-530B-E30C-002F-3C98FC7FE8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5629870"/>
              </p:ext>
            </p:extLst>
          </p:nvPr>
        </p:nvGraphicFramePr>
        <p:xfrm>
          <a:off x="330609" y="1794523"/>
          <a:ext cx="11724542" cy="2768146"/>
        </p:xfrm>
        <a:graphic>
          <a:graphicData uri="http://schemas.openxmlformats.org/drawingml/2006/table">
            <a:tbl>
              <a:tblPr firstRow="1" bandRow="1">
                <a:solidFill>
                  <a:srgbClr val="F2F2F2">
                    <a:alpha val="45098"/>
                  </a:srgbClr>
                </a:solidFill>
              </a:tblPr>
              <a:tblGrid>
                <a:gridCol w="2879275">
                  <a:extLst>
                    <a:ext uri="{9D8B030D-6E8A-4147-A177-3AD203B41FA5}">
                      <a16:colId xmlns:a16="http://schemas.microsoft.com/office/drawing/2014/main" val="179982056"/>
                    </a:ext>
                  </a:extLst>
                </a:gridCol>
                <a:gridCol w="1469210">
                  <a:extLst>
                    <a:ext uri="{9D8B030D-6E8A-4147-A177-3AD203B41FA5}">
                      <a16:colId xmlns:a16="http://schemas.microsoft.com/office/drawing/2014/main" val="1150873693"/>
                    </a:ext>
                  </a:extLst>
                </a:gridCol>
                <a:gridCol w="1683506">
                  <a:extLst>
                    <a:ext uri="{9D8B030D-6E8A-4147-A177-3AD203B41FA5}">
                      <a16:colId xmlns:a16="http://schemas.microsoft.com/office/drawing/2014/main" val="1292806175"/>
                    </a:ext>
                  </a:extLst>
                </a:gridCol>
                <a:gridCol w="1469210">
                  <a:extLst>
                    <a:ext uri="{9D8B030D-6E8A-4147-A177-3AD203B41FA5}">
                      <a16:colId xmlns:a16="http://schemas.microsoft.com/office/drawing/2014/main" val="2230072834"/>
                    </a:ext>
                  </a:extLst>
                </a:gridCol>
                <a:gridCol w="1327777">
                  <a:extLst>
                    <a:ext uri="{9D8B030D-6E8A-4147-A177-3AD203B41FA5}">
                      <a16:colId xmlns:a16="http://schemas.microsoft.com/office/drawing/2014/main" val="3475956480"/>
                    </a:ext>
                  </a:extLst>
                </a:gridCol>
                <a:gridCol w="1507785">
                  <a:extLst>
                    <a:ext uri="{9D8B030D-6E8A-4147-A177-3AD203B41FA5}">
                      <a16:colId xmlns:a16="http://schemas.microsoft.com/office/drawing/2014/main" val="2173960344"/>
                    </a:ext>
                  </a:extLst>
                </a:gridCol>
                <a:gridCol w="1387779">
                  <a:extLst>
                    <a:ext uri="{9D8B030D-6E8A-4147-A177-3AD203B41FA5}">
                      <a16:colId xmlns:a16="http://schemas.microsoft.com/office/drawing/2014/main" val="1112899246"/>
                    </a:ext>
                  </a:extLst>
                </a:gridCol>
              </a:tblGrid>
              <a:tr h="874348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cap="none" spc="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Model</a:t>
                      </a:r>
                    </a:p>
                  </a:txBody>
                  <a:tcPr marL="18451" marR="18451" marT="22141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</a:lnT>
                    <a:lnB w="38100" cmpd="sng">
                      <a:noFill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cap="none" spc="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S effect</a:t>
                      </a:r>
                    </a:p>
                  </a:txBody>
                  <a:tcPr marL="18451" marR="18451" marT="22141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</a:lnT>
                    <a:lnB w="38100" cmpd="sng">
                      <a:noFill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cap="none" spc="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S error</a:t>
                      </a:r>
                    </a:p>
                  </a:txBody>
                  <a:tcPr marL="18451" marR="18451" marT="22141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</a:lnT>
                    <a:lnB w="38100" cmpd="sng">
                      <a:noFill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cap="none" spc="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DF effect</a:t>
                      </a:r>
                    </a:p>
                  </a:txBody>
                  <a:tcPr marL="18451" marR="18451" marT="22141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</a:lnT>
                    <a:lnB w="38100" cmpd="sng">
                      <a:noFill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cap="none" spc="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DF error</a:t>
                      </a:r>
                    </a:p>
                  </a:txBody>
                  <a:tcPr marL="18451" marR="18451" marT="22141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</a:lnT>
                    <a:lnB w="38100" cmpd="sng">
                      <a:noFill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cap="none" spc="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F-value.</a:t>
                      </a:r>
                    </a:p>
                  </a:txBody>
                  <a:tcPr marL="18451" marR="18451" marT="22141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</a:lnT>
                    <a:lnB w="38100" cmpd="sng">
                      <a:noFill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cap="none" spc="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18451" marR="18451" marT="22141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</a:lnT>
                    <a:lnB w="38100" cmpd="sng">
                      <a:noFill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0699658"/>
                  </a:ext>
                </a:extLst>
              </a:tr>
              <a:tr h="731695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0" i="0" u="none" strike="noStrike" cap="none" spc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ogistic power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B>
                    <a:solidFill>
                      <a:srgbClr val="F2F2F2">
                        <a:alpha val="45098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.533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B>
                    <a:solidFill>
                      <a:srgbClr val="F2F2F2">
                        <a:alpha val="45098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13.505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B>
                    <a:solidFill>
                      <a:srgbClr val="F2F2F2">
                        <a:alpha val="45098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B>
                    <a:solidFill>
                      <a:srgbClr val="F2F2F2">
                        <a:alpha val="45098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165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B>
                    <a:solidFill>
                      <a:srgbClr val="F2F2F2">
                        <a:alpha val="45098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2.363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B>
                    <a:solidFill>
                      <a:srgbClr val="F2F2F2">
                        <a:alpha val="45098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lt;0.01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B>
                    <a:solidFill>
                      <a:srgbClr val="F2F2F2">
                        <a:alpha val="45098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0938795"/>
                  </a:ext>
                </a:extLst>
              </a:tr>
              <a:tr h="1162103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0" i="0" u="none" strike="noStrike" cap="none" spc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Bayesian latent class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rgbClr val="BFBFBF">
                        <a:alpha val="3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.18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rgbClr val="BFBFBF">
                        <a:alpha val="3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70.469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rgbClr val="BFBFBF">
                        <a:alpha val="3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rgbClr val="BFBFBF">
                        <a:alpha val="3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165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rgbClr val="BFBFBF">
                        <a:alpha val="3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900" b="0" i="0" u="none" strike="noStrike" cap="none" spc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8.958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rgbClr val="BFBFBF">
                        <a:alpha val="3490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900" b="0" i="0" u="none" strike="noStrike" cap="none" spc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lt;0.01</a:t>
                      </a:r>
                    </a:p>
                  </a:txBody>
                  <a:tcPr marL="18451" marR="18451" marT="221413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rgbClr val="BFBFBF">
                        <a:alpha val="34902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88799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554253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99ED5833-B85B-4103-8A3B-CAB0308E6C1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73F3CAFD-7B39-4656-83C9-D3028F36A8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6965" y="436495"/>
            <a:ext cx="12015019" cy="554182"/>
          </a:xfrm>
        </p:spPr>
        <p:txBody>
          <a:bodyPr vert="horz" lIns="91440" tIns="45720" rIns="91440" bIns="45720" rtlCol="0" anchor="b">
            <a:normAutofit fontScale="90000"/>
          </a:bodyPr>
          <a:lstStyle/>
          <a:p>
            <a:pPr algn="ctr"/>
            <a:r>
              <a:rPr lang="en-GB" sz="3200" dirty="0"/>
              <a:t>Supplementary </a:t>
            </a:r>
            <a:r>
              <a:rPr lang="en-US" sz="3200" dirty="0"/>
              <a:t>Fig 3: Comparison of probability of febrile and non-febrile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99F6DE22-FF0C-4F9B-BCA4-2482AB0F784E}"/>
              </a:ext>
            </a:extLst>
          </p:cNvPr>
          <p:cNvGrpSpPr/>
          <p:nvPr/>
        </p:nvGrpSpPr>
        <p:grpSpPr>
          <a:xfrm>
            <a:off x="740726" y="1923351"/>
            <a:ext cx="10498899" cy="4686558"/>
            <a:chOff x="729415" y="1617483"/>
            <a:chExt cx="10498899" cy="468655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85C3C11-98C2-476C-BC80-0452196B68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29415" y="1617483"/>
              <a:ext cx="5858198" cy="4686558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3136600-1B52-4B7D-89B4-A573D4FD13E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82993" y="1727269"/>
              <a:ext cx="5745321" cy="4466987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E07DA5CC-8855-41AE-99FD-2FD48590A1F5}"/>
              </a:ext>
            </a:extLst>
          </p:cNvPr>
          <p:cNvSpPr txBox="1"/>
          <p:nvPr/>
        </p:nvSpPr>
        <p:spPr>
          <a:xfrm>
            <a:off x="1376516" y="1675261"/>
            <a:ext cx="1588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l participants</a:t>
            </a:r>
            <a:endParaRPr lang="en-GB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1FAE01-1BD0-486D-A924-7E82311552C7}"/>
              </a:ext>
            </a:extLst>
          </p:cNvPr>
          <p:cNvSpPr txBox="1"/>
          <p:nvPr/>
        </p:nvSpPr>
        <p:spPr>
          <a:xfrm>
            <a:off x="6282813" y="1734254"/>
            <a:ext cx="2878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rasite positive participant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655260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3E46FFE-27B8-4BB1-B3C4-B10B764093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7160" y="914400"/>
            <a:ext cx="10332117" cy="5578475"/>
          </a:xfrm>
          <a:prstGeom prst="rect">
            <a:avLst/>
          </a:prstGeom>
        </p:spPr>
      </p:pic>
      <p:sp>
        <p:nvSpPr>
          <p:cNvPr id="3" name="Title 2">
            <a:extLst>
              <a:ext uri="{FF2B5EF4-FFF2-40B4-BE49-F238E27FC236}">
                <a16:creationId xmlns:a16="http://schemas.microsoft.com/office/drawing/2014/main" id="{C54C064A-C49E-4972-A96B-34B0A57676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5418" y="138984"/>
            <a:ext cx="10515600" cy="644788"/>
          </a:xfrm>
        </p:spPr>
        <p:txBody>
          <a:bodyPr>
            <a:normAutofit/>
          </a:bodyPr>
          <a:lstStyle/>
          <a:p>
            <a:r>
              <a:rPr lang="en-GB" sz="3200" dirty="0"/>
              <a:t>Supplementary </a:t>
            </a:r>
            <a:r>
              <a:rPr lang="en-US" sz="3200" dirty="0"/>
              <a:t>Fig 4: Predicted probabilities over age groups</a:t>
            </a:r>
            <a:endParaRPr lang="en-GB" sz="3200" dirty="0"/>
          </a:p>
        </p:txBody>
      </p:sp>
    </p:spTree>
    <p:extLst>
      <p:ext uri="{BB962C8B-B14F-4D97-AF65-F5344CB8AC3E}">
        <p14:creationId xmlns:p14="http://schemas.microsoft.com/office/powerpoint/2010/main" val="12694496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8110A14-7736-4A10-851F-96F90D5CC68B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6637" y="1019589"/>
            <a:ext cx="6218726" cy="5838411"/>
          </a:xfrm>
          <a:prstGeom prst="rect">
            <a:avLst/>
          </a:prstGeom>
        </p:spPr>
      </p:pic>
      <p:sp>
        <p:nvSpPr>
          <p:cNvPr id="6" name="Title 5">
            <a:extLst>
              <a:ext uri="{FF2B5EF4-FFF2-40B4-BE49-F238E27FC236}">
                <a16:creationId xmlns:a16="http://schemas.microsoft.com/office/drawing/2014/main" id="{8F7FC090-AA8F-414F-AD82-FD3554FE67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92393" y="158648"/>
            <a:ext cx="10515600" cy="677094"/>
          </a:xfrm>
        </p:spPr>
        <p:txBody>
          <a:bodyPr>
            <a:noAutofit/>
          </a:bodyPr>
          <a:lstStyle/>
          <a:p>
            <a:r>
              <a:rPr lang="en-GB" sz="3200" dirty="0"/>
              <a:t>Supplementary </a:t>
            </a:r>
            <a:r>
              <a:rPr lang="en-US" sz="3200" dirty="0"/>
              <a:t>Fig 5: Sensitivity and specificity of the different years</a:t>
            </a:r>
            <a:endParaRPr lang="en-GB" sz="3200" dirty="0"/>
          </a:p>
        </p:txBody>
      </p:sp>
    </p:spTree>
    <p:extLst>
      <p:ext uri="{BB962C8B-B14F-4D97-AF65-F5344CB8AC3E}">
        <p14:creationId xmlns:p14="http://schemas.microsoft.com/office/powerpoint/2010/main" val="42358210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422F5-2AFF-413A-A347-A39BCB8360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4236" y="407720"/>
            <a:ext cx="10515600" cy="577932"/>
          </a:xfrm>
        </p:spPr>
        <p:txBody>
          <a:bodyPr>
            <a:normAutofit/>
          </a:bodyPr>
          <a:lstStyle/>
          <a:p>
            <a:r>
              <a:rPr lang="en-GB" sz="3200" dirty="0"/>
              <a:t>Supplementary </a:t>
            </a:r>
            <a:r>
              <a:rPr lang="en-US" sz="3200" dirty="0"/>
              <a:t>Fig 6: Posterior estimates of AF</a:t>
            </a:r>
            <a:endParaRPr lang="en-GB" sz="3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70A5708-BCBD-4DCA-A529-9319840C791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889"/>
          <a:stretch/>
        </p:blipFill>
        <p:spPr>
          <a:xfrm>
            <a:off x="1381353" y="885842"/>
            <a:ext cx="7613356" cy="5564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6904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12</TotalTime>
  <Words>324</Words>
  <Application>Microsoft Office PowerPoint</Application>
  <PresentationFormat>Widescreen</PresentationFormat>
  <Paragraphs>13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Cambria</vt:lpstr>
      <vt:lpstr>Tahoma</vt:lpstr>
      <vt:lpstr>Office Theme</vt:lpstr>
      <vt:lpstr>Supplementary Table 1 :Parasites/µL cut off using Logistic regression</vt:lpstr>
      <vt:lpstr>Supplementary Fig 1: Distribution of predicted probabilities</vt:lpstr>
      <vt:lpstr>Supplementary Fig 2: Comparison of probabilities for Bayesian and Logistic, Junju 2008</vt:lpstr>
      <vt:lpstr>Supplementary Table 2: Anova test for Figure 2B</vt:lpstr>
      <vt:lpstr>Supplementary Fig 3: Comparison of probability of febrile and non-febrile</vt:lpstr>
      <vt:lpstr>Supplementary Fig 4: Predicted probabilities over age groups</vt:lpstr>
      <vt:lpstr>Supplementary Fig 5: Sensitivity and specificity of the different years</vt:lpstr>
      <vt:lpstr>Supplementary Fig 6: Posterior estimates of AF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nedy Mwai</dc:creator>
  <cp:lastModifiedBy>Kennedy Mwai</cp:lastModifiedBy>
  <cp:revision>31</cp:revision>
  <dcterms:created xsi:type="dcterms:W3CDTF">2021-06-08T20:47:50Z</dcterms:created>
  <dcterms:modified xsi:type="dcterms:W3CDTF">2022-10-22T08:45:13Z</dcterms:modified>
</cp:coreProperties>
</file>